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1/0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3845" y="5518973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devall-Hagren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9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Primary cilia as sensors of the islet environment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41C2150-6A57-0935-DCA7-9ECF01092F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7237" y="1209038"/>
            <a:ext cx="5125550" cy="44399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ignal transduction in the beta cell primary cilium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2F90942-70D9-F6B3-9761-2786F64F29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3768" y="836712"/>
            <a:ext cx="4176464" cy="502431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B8FF27B-8258-6A01-93F9-BD90A9731960}"/>
              </a:ext>
            </a:extLst>
          </p:cNvPr>
          <p:cNvSpPr txBox="1"/>
          <p:nvPr/>
        </p:nvSpPr>
        <p:spPr>
          <a:xfrm>
            <a:off x="213845" y="5518973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devall-Hagren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9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GABA signalling in the beta cell primary cilium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ED5EB2E-D6B9-DB89-5D74-745971CF57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878"/>
          <a:stretch/>
        </p:blipFill>
        <p:spPr>
          <a:xfrm>
            <a:off x="1663417" y="943839"/>
            <a:ext cx="5817166" cy="49703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AA7563F-3DB9-2C08-A5E3-FE42396DF151}"/>
              </a:ext>
            </a:extLst>
          </p:cNvPr>
          <p:cNvSpPr txBox="1"/>
          <p:nvPr/>
        </p:nvSpPr>
        <p:spPr>
          <a:xfrm>
            <a:off x="213845" y="5518973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devall-Hagren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9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On-screen Show (4:3)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50</cp:revision>
  <dcterms:created xsi:type="dcterms:W3CDTF">2016-06-15T12:53:43Z</dcterms:created>
  <dcterms:modified xsi:type="dcterms:W3CDTF">2024-01-31T10:31:41Z</dcterms:modified>
</cp:coreProperties>
</file>